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1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2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3.xml" ContentType="application/vnd.openxmlformats-officedocument.themeOverr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4.xml" ContentType="application/vnd.openxmlformats-officedocument.themeOverr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5.xml" ContentType="application/vnd.openxmlformats-officedocument.themeOverrid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theme/themeOverride6.xml" ContentType="application/vnd.openxmlformats-officedocument.themeOverrid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theme/themeOverride7.xml" ContentType="application/vnd.openxmlformats-officedocument.themeOverrid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theme/themeOverride8.xml" ContentType="application/vnd.openxmlformats-officedocument.themeOverrid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theme/themeOverride9.xml" ContentType="application/vnd.openxmlformats-officedocument.themeOverrid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theme/themeOverride10.xml" ContentType="application/vnd.openxmlformats-officedocument.themeOverrid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theme/themeOverride1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  <p:sldId id="266" r:id="rId3"/>
    <p:sldId id="267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176" userDrawn="1">
          <p15:clr>
            <a:srgbClr val="A4A3A4"/>
          </p15:clr>
        </p15:guide>
        <p15:guide id="2" pos="37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06" autoAdjust="0"/>
    <p:restoredTop sz="94660"/>
  </p:normalViewPr>
  <p:slideViewPr>
    <p:cSldViewPr snapToGrid="0" showGuides="1">
      <p:cViewPr>
        <p:scale>
          <a:sx n="136" d="100"/>
          <a:sy n="136" d="100"/>
        </p:scale>
        <p:origin x="-366" y="-234"/>
      </p:cViewPr>
      <p:guideLst>
        <p:guide orient="horz" pos="4176"/>
        <p:guide pos="37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Ref%20gene\Efficiency%20analysi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9.xml"/><Relationship Id="rId2" Type="http://schemas.microsoft.com/office/2011/relationships/chartColorStyle" Target="colors10.xml"/><Relationship Id="rId1" Type="http://schemas.microsoft.com/office/2011/relationships/chartStyle" Target="style10.xml"/><Relationship Id="rId4" Type="http://schemas.openxmlformats.org/officeDocument/2006/relationships/oleObject" Target="file:///F:\Ref%20gene\Efficiency%20analysis.xlsx" TargetMode="Externa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0.xml"/><Relationship Id="rId2" Type="http://schemas.microsoft.com/office/2011/relationships/chartColorStyle" Target="colors11.xml"/><Relationship Id="rId1" Type="http://schemas.microsoft.com/office/2011/relationships/chartStyle" Target="style11.xml"/><Relationship Id="rId4" Type="http://schemas.openxmlformats.org/officeDocument/2006/relationships/oleObject" Target="file:///F:\Ref%20gene\Efficiency%20analysis.xlsx" TargetMode="Externa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1.xml"/><Relationship Id="rId2" Type="http://schemas.microsoft.com/office/2011/relationships/chartColorStyle" Target="colors12.xml"/><Relationship Id="rId1" Type="http://schemas.microsoft.com/office/2011/relationships/chartStyle" Target="style12.xml"/><Relationship Id="rId4" Type="http://schemas.openxmlformats.org/officeDocument/2006/relationships/oleObject" Target="file:///D:\Acedemic%20items\Sci_Rep_AtuRG_Revision1\Ref%20gene\Efficiency%20analysis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F:\Ref%20gene\Efficiency%20analysis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file:///F:\Ref%20gene\Efficiency%20analysis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oleObject" Target="file:///F:\Ref%20gene\Efficiency%20analysis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oleObject" Target="file:///F:\Ref%20gene\Efficiency%20analysis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oleObject" Target="file:///F:\Ref%20gene\Efficiency%20analysis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6.xml"/><Relationship Id="rId2" Type="http://schemas.microsoft.com/office/2011/relationships/chartColorStyle" Target="colors7.xml"/><Relationship Id="rId1" Type="http://schemas.microsoft.com/office/2011/relationships/chartStyle" Target="style7.xml"/><Relationship Id="rId4" Type="http://schemas.openxmlformats.org/officeDocument/2006/relationships/oleObject" Target="file:///F:\Ref%20gene\Efficiency%20analysis.xlsx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7.xml"/><Relationship Id="rId2" Type="http://schemas.microsoft.com/office/2011/relationships/chartColorStyle" Target="colors8.xml"/><Relationship Id="rId1" Type="http://schemas.microsoft.com/office/2011/relationships/chartStyle" Target="style8.xml"/><Relationship Id="rId4" Type="http://schemas.openxmlformats.org/officeDocument/2006/relationships/oleObject" Target="file:///F:\Ref%20gene\Efficiency%20analysis.xlsx" TargetMode="Externa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8.xml"/><Relationship Id="rId2" Type="http://schemas.microsoft.com/office/2011/relationships/chartColorStyle" Target="colors9.xml"/><Relationship Id="rId1" Type="http://schemas.microsoft.com/office/2011/relationships/chartStyle" Target="style9.xml"/><Relationship Id="rId4" Type="http://schemas.openxmlformats.org/officeDocument/2006/relationships/oleObject" Target="file:///F:\Ref%20gene\Efficiency%20analysi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5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N12657_c0_g1</a:t>
            </a:r>
          </a:p>
        </c:rich>
      </c:tx>
      <c:layout>
        <c:manualLayout>
          <c:xMode val="edge"/>
          <c:yMode val="edge"/>
          <c:x val="0.2733490498540439"/>
          <c:y val="1.469045363426785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5.2962766870814491E-2"/>
          <c:y val="0.16225606039048845"/>
          <c:w val="0.84722611756625266"/>
          <c:h val="0.70407353555263286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63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21222812088603973"/>
                  <c:y val="3.9020505328470449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1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zh-CN"/>
                </a:p>
              </c:txPr>
            </c:trendlineLbl>
          </c:trendline>
          <c:xVal>
            <c:numRef>
              <c:f>Sheet1!$O$3:$T$3</c:f>
              <c:numCache>
                <c:formatCode>General</c:formatCode>
                <c:ptCount val="6"/>
                <c:pt idx="0">
                  <c:v>-1</c:v>
                </c:pt>
                <c:pt idx="1">
                  <c:v>-2</c:v>
                </c:pt>
                <c:pt idx="2">
                  <c:v>-3</c:v>
                </c:pt>
                <c:pt idx="3">
                  <c:v>-4</c:v>
                </c:pt>
                <c:pt idx="4">
                  <c:v>-5</c:v>
                </c:pt>
                <c:pt idx="5">
                  <c:v>-6</c:v>
                </c:pt>
              </c:numCache>
            </c:numRef>
          </c:xVal>
          <c:yVal>
            <c:numRef>
              <c:f>Sheet1!$O$4:$T$4</c:f>
              <c:numCache>
                <c:formatCode>General</c:formatCode>
                <c:ptCount val="6"/>
                <c:pt idx="0">
                  <c:v>11.486666666666666</c:v>
                </c:pt>
                <c:pt idx="1">
                  <c:v>13.076666666666666</c:v>
                </c:pt>
                <c:pt idx="2">
                  <c:v>17.283333333333331</c:v>
                </c:pt>
                <c:pt idx="3">
                  <c:v>20.536666666666665</c:v>
                </c:pt>
                <c:pt idx="4">
                  <c:v>23.283333333333331</c:v>
                </c:pt>
                <c:pt idx="5">
                  <c:v>27.05333333333333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30A5-43C2-9CD4-CA9144B21B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17004640"/>
        <c:axId val="317005200"/>
      </c:scatterChart>
      <c:valAx>
        <c:axId val="3170046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317005200"/>
        <c:crosses val="autoZero"/>
        <c:crossBetween val="midCat"/>
      </c:valAx>
      <c:valAx>
        <c:axId val="317005200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31700464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05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050" b="1" i="0" u="none" strike="noStrike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N17056_c0_g1</a:t>
            </a:r>
          </a:p>
          <a:p>
            <a:pPr>
              <a:defRPr sz="105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sz="1050" b="1" i="0" u="none" strike="noStrike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050" b="1" i="0" u="none" strike="noStrike" baseline="0" dirty="0">
                <a:effectLst/>
              </a:rPr>
              <a:t>eIF5A</a:t>
            </a:r>
            <a:r>
              <a:rPr lang="en-US" sz="1050" b="1" i="0" u="none" strike="noStrike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05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19921592681349615"/>
          <c:y val="4.7697162854643156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5.2962766870814491E-2"/>
          <c:y val="0.16225606039048845"/>
          <c:w val="0.84722611756625266"/>
          <c:h val="0.70407353555263286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63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18478456656654232"/>
                  <c:y val="0.15998160716289916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1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zh-CN"/>
                </a:p>
              </c:txPr>
            </c:trendlineLbl>
          </c:trendline>
          <c:xVal>
            <c:numRef>
              <c:f>Sheet1!$O$43:$T$43</c:f>
              <c:numCache>
                <c:formatCode>General</c:formatCode>
                <c:ptCount val="6"/>
                <c:pt idx="0">
                  <c:v>-1</c:v>
                </c:pt>
                <c:pt idx="1">
                  <c:v>-2</c:v>
                </c:pt>
                <c:pt idx="2">
                  <c:v>-3</c:v>
                </c:pt>
                <c:pt idx="3">
                  <c:v>-4</c:v>
                </c:pt>
                <c:pt idx="4">
                  <c:v>-5</c:v>
                </c:pt>
                <c:pt idx="5">
                  <c:v>-6</c:v>
                </c:pt>
              </c:numCache>
            </c:numRef>
          </c:xVal>
          <c:yVal>
            <c:numRef>
              <c:f>Sheet1!$O$44:$T$44</c:f>
              <c:numCache>
                <c:formatCode>0.00</c:formatCode>
                <c:ptCount val="6"/>
                <c:pt idx="0" formatCode="0">
                  <c:v>18.676666666666666</c:v>
                </c:pt>
                <c:pt idx="1">
                  <c:v>22.206666666666667</c:v>
                </c:pt>
                <c:pt idx="2">
                  <c:v>24.433333333333337</c:v>
                </c:pt>
                <c:pt idx="3">
                  <c:v>27.816666666666666</c:v>
                </c:pt>
                <c:pt idx="4">
                  <c:v>31.12</c:v>
                </c:pt>
                <c:pt idx="5">
                  <c:v>34.41333333333333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DE63-4012-82B5-7356FF1A986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46784352"/>
        <c:axId val="246784912"/>
      </c:scatterChart>
      <c:valAx>
        <c:axId val="2467843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46784912"/>
        <c:crosses val="autoZero"/>
        <c:crossBetween val="midCat"/>
      </c:valAx>
      <c:valAx>
        <c:axId val="246784912"/>
        <c:scaling>
          <c:orientation val="minMax"/>
        </c:scaling>
        <c:delete val="0"/>
        <c:axPos val="l"/>
        <c:numFmt formatCode="0" sourceLinked="1"/>
        <c:majorTickMark val="in"/>
        <c:minorTickMark val="none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46784352"/>
        <c:crosses val="autoZero"/>
        <c:crossBetween val="midCat"/>
        <c:majorUnit val="25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4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050" b="1" i="0" u="none" strike="noStrike" kern="1200" spc="0" baseline="0">
                <a:solidFill>
                  <a:prstClr val="black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DN2684_c0_g1</a:t>
            </a: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050" b="1">
                <a:solidFill>
                  <a:prstClr val="black"/>
                </a:solidFill>
              </a:defRPr>
            </a:pPr>
            <a:r>
              <a:rPr lang="en-US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050" b="1" i="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CT2</a:t>
            </a:r>
            <a:r>
              <a:rPr lang="en-US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c:rich>
      </c:tx>
      <c:layout>
        <c:manualLayout>
          <c:xMode val="edge"/>
          <c:yMode val="edge"/>
          <c:x val="0.2552331773745673"/>
          <c:y val="1.469035120609923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marL="0" marR="0" lvl="0" indent="0" algn="ctr" defTabSz="914400" rtl="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 sz="1050" b="1" i="0" u="none" strike="noStrike" kern="1200" spc="0" baseline="0">
              <a:solidFill>
                <a:prstClr val="black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5.2962766870814491E-2"/>
          <c:y val="0.16225606039048845"/>
          <c:w val="0.84722611756625266"/>
          <c:h val="0.70407353555263286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63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21222812088603973"/>
                  <c:y val="3.9020505328470449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05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zh-CN"/>
                </a:p>
              </c:txPr>
            </c:trendlineLbl>
          </c:trendline>
          <c:xVal>
            <c:numRef>
              <c:f>Sheet1!$O$47:$T$47</c:f>
              <c:numCache>
                <c:formatCode>General</c:formatCode>
                <c:ptCount val="6"/>
                <c:pt idx="0">
                  <c:v>-1</c:v>
                </c:pt>
                <c:pt idx="1">
                  <c:v>-2</c:v>
                </c:pt>
                <c:pt idx="2">
                  <c:v>-3</c:v>
                </c:pt>
                <c:pt idx="3">
                  <c:v>-4</c:v>
                </c:pt>
                <c:pt idx="4">
                  <c:v>-5</c:v>
                </c:pt>
                <c:pt idx="5">
                  <c:v>-6</c:v>
                </c:pt>
              </c:numCache>
            </c:numRef>
          </c:xVal>
          <c:yVal>
            <c:numRef>
              <c:f>Sheet1!$O$48:$T$48</c:f>
              <c:numCache>
                <c:formatCode>General</c:formatCode>
                <c:ptCount val="6"/>
                <c:pt idx="1">
                  <c:v>15.346666666666666</c:v>
                </c:pt>
                <c:pt idx="2">
                  <c:v>18.806666666666668</c:v>
                </c:pt>
                <c:pt idx="3">
                  <c:v>21.87</c:v>
                </c:pt>
                <c:pt idx="4">
                  <c:v>24.936666666666667</c:v>
                </c:pt>
                <c:pt idx="5">
                  <c:v>29.07666666666666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69A7-4F5D-B0C6-7C9F80C1AE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46787152"/>
        <c:axId val="242719856"/>
      </c:scatterChart>
      <c:valAx>
        <c:axId val="2467871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242719856"/>
        <c:crosses val="autoZero"/>
        <c:crossBetween val="midCat"/>
      </c:valAx>
      <c:valAx>
        <c:axId val="24271985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246787152"/>
        <c:crosses val="autoZero"/>
        <c:crossBetween val="midCat"/>
        <c:majorUnit val="25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050"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4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05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05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N2022_c2_g1</a:t>
            </a:r>
          </a:p>
        </c:rich>
      </c:tx>
      <c:layout>
        <c:manualLayout>
          <c:xMode val="edge"/>
          <c:yMode val="edge"/>
          <c:x val="0.2733490498540439"/>
          <c:y val="1.469045363426785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5.2962766870814491E-2"/>
          <c:y val="0.16225606039048845"/>
          <c:w val="0.84722611756625266"/>
          <c:h val="0.70407353555263286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63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21222812088603973"/>
                  <c:y val="3.9020505328470449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1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zh-CN"/>
                </a:p>
              </c:txPr>
            </c:trendlineLbl>
          </c:trendline>
          <c:xVal>
            <c:numRef>
              <c:f>Sheet1!$O$19:$T$19</c:f>
              <c:numCache>
                <c:formatCode>General</c:formatCode>
                <c:ptCount val="6"/>
                <c:pt idx="0">
                  <c:v>-1</c:v>
                </c:pt>
                <c:pt idx="1">
                  <c:v>-2</c:v>
                </c:pt>
                <c:pt idx="2">
                  <c:v>-3</c:v>
                </c:pt>
                <c:pt idx="3">
                  <c:v>-4</c:v>
                </c:pt>
                <c:pt idx="4">
                  <c:v>-5</c:v>
                </c:pt>
                <c:pt idx="5">
                  <c:v>-6</c:v>
                </c:pt>
              </c:numCache>
            </c:numRef>
          </c:xVal>
          <c:yVal>
            <c:numRef>
              <c:f>Sheet1!$O$20:$T$20</c:f>
              <c:numCache>
                <c:formatCode>0.00</c:formatCode>
                <c:ptCount val="6"/>
                <c:pt idx="1">
                  <c:v>19.356666666666666</c:v>
                </c:pt>
                <c:pt idx="2">
                  <c:v>22.736666666666668</c:v>
                </c:pt>
                <c:pt idx="3">
                  <c:v>25.400000000000002</c:v>
                </c:pt>
                <c:pt idx="4">
                  <c:v>28.7</c:v>
                </c:pt>
                <c:pt idx="5">
                  <c:v>32.1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0BC0-4594-81BB-CCE165E6F77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42722096"/>
        <c:axId val="242722656"/>
      </c:scatterChart>
      <c:valAx>
        <c:axId val="2427220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42722656"/>
        <c:crosses val="autoZero"/>
        <c:crossBetween val="midCat"/>
      </c:valAx>
      <c:valAx>
        <c:axId val="242722656"/>
        <c:scaling>
          <c:orientation val="minMax"/>
        </c:scaling>
        <c:delete val="0"/>
        <c:axPos val="l"/>
        <c:numFmt formatCode="0.00" sourceLinked="1"/>
        <c:majorTickMark val="in"/>
        <c:minorTickMark val="none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4272209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05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N253_c0_g1</a:t>
            </a:r>
          </a:p>
          <a:p>
            <a:pPr>
              <a:defRPr sz="105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SKP1)</a:t>
            </a:r>
          </a:p>
        </c:rich>
      </c:tx>
      <c:layout>
        <c:manualLayout>
          <c:xMode val="edge"/>
          <c:yMode val="edge"/>
          <c:x val="0.2733490498540439"/>
          <c:y val="1.469045363426785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5.2962766870814491E-2"/>
          <c:y val="0.16225606039048845"/>
          <c:w val="0.84722611756625266"/>
          <c:h val="0.70407353555263286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63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21222812088603973"/>
                  <c:y val="3.9020505328470449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1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zh-CN"/>
                </a:p>
              </c:txPr>
            </c:trendlineLbl>
          </c:trendline>
          <c:xVal>
            <c:numRef>
              <c:f>Sheet1!$O$7:$T$7</c:f>
              <c:numCache>
                <c:formatCode>General</c:formatCode>
                <c:ptCount val="6"/>
                <c:pt idx="0">
                  <c:v>-1</c:v>
                </c:pt>
                <c:pt idx="1">
                  <c:v>-2</c:v>
                </c:pt>
                <c:pt idx="2">
                  <c:v>-3</c:v>
                </c:pt>
                <c:pt idx="3">
                  <c:v>-4</c:v>
                </c:pt>
                <c:pt idx="4">
                  <c:v>-5</c:v>
                </c:pt>
                <c:pt idx="5">
                  <c:v>-6</c:v>
                </c:pt>
              </c:numCache>
            </c:numRef>
          </c:xVal>
          <c:yVal>
            <c:numRef>
              <c:f>Sheet1!$O$8:$T$8</c:f>
              <c:numCache>
                <c:formatCode>General</c:formatCode>
                <c:ptCount val="6"/>
                <c:pt idx="1">
                  <c:v>23.733333333333334</c:v>
                </c:pt>
                <c:pt idx="2">
                  <c:v>27.02333333333333</c:v>
                </c:pt>
                <c:pt idx="3">
                  <c:v>31.166666666666668</c:v>
                </c:pt>
                <c:pt idx="4">
                  <c:v>34.309999999999995</c:v>
                </c:pt>
                <c:pt idx="5">
                  <c:v>37.61666666666666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0785-452D-900E-93D44DC84B0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39977520"/>
        <c:axId val="139978080"/>
      </c:scatterChart>
      <c:valAx>
        <c:axId val="1399775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39978080"/>
        <c:crosses val="autoZero"/>
        <c:crossBetween val="midCat"/>
      </c:valAx>
      <c:valAx>
        <c:axId val="139978080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3997752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05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6928_c0_g1</a:t>
            </a:r>
          </a:p>
          <a:p>
            <a:pPr>
              <a:defRPr sz="105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BS_X3)</a:t>
            </a:r>
          </a:p>
        </c:rich>
      </c:tx>
      <c:layout>
        <c:manualLayout>
          <c:xMode val="edge"/>
          <c:yMode val="edge"/>
          <c:x val="0.2733490498540439"/>
          <c:y val="1.469045363426785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5.2962766870814491E-2"/>
          <c:y val="0.16225606039048845"/>
          <c:w val="0.84722611756625266"/>
          <c:h val="0.70407353555263286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63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21222812088603973"/>
                  <c:y val="3.9020505328470449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1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zh-CN"/>
                </a:p>
              </c:txPr>
            </c:trendlineLbl>
          </c:trendline>
          <c:xVal>
            <c:numRef>
              <c:f>Sheet1!$O$11:$T$11</c:f>
              <c:numCache>
                <c:formatCode>General</c:formatCode>
                <c:ptCount val="6"/>
                <c:pt idx="0">
                  <c:v>-1</c:v>
                </c:pt>
                <c:pt idx="1">
                  <c:v>-2</c:v>
                </c:pt>
                <c:pt idx="2">
                  <c:v>-3</c:v>
                </c:pt>
                <c:pt idx="3">
                  <c:v>-4</c:v>
                </c:pt>
                <c:pt idx="4">
                  <c:v>-5</c:v>
                </c:pt>
                <c:pt idx="5">
                  <c:v>-6</c:v>
                </c:pt>
              </c:numCache>
            </c:numRef>
          </c:xVal>
          <c:yVal>
            <c:numRef>
              <c:f>Sheet1!$O$12:$T$12</c:f>
              <c:numCache>
                <c:formatCode>General</c:formatCode>
                <c:ptCount val="6"/>
                <c:pt idx="0">
                  <c:v>14.456666666666665</c:v>
                </c:pt>
                <c:pt idx="1">
                  <c:v>17.506666666666664</c:v>
                </c:pt>
                <c:pt idx="2">
                  <c:v>19.14</c:v>
                </c:pt>
                <c:pt idx="3">
                  <c:v>22.44</c:v>
                </c:pt>
                <c:pt idx="4">
                  <c:v>28.14</c:v>
                </c:pt>
                <c:pt idx="5">
                  <c:v>32.08666666666666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3C20-4EA1-8383-3C36968461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32432192"/>
        <c:axId val="232432752"/>
      </c:scatterChart>
      <c:valAx>
        <c:axId val="2324321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32432752"/>
        <c:crosses val="autoZero"/>
        <c:crossBetween val="midCat"/>
      </c:valAx>
      <c:valAx>
        <c:axId val="232432752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324321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05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N18197_c0_g1</a:t>
            </a:r>
          </a:p>
          <a:p>
            <a:pPr>
              <a:defRPr sz="105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PGRMC1)</a:t>
            </a:r>
          </a:p>
        </c:rich>
      </c:tx>
      <c:layout>
        <c:manualLayout>
          <c:xMode val="edge"/>
          <c:yMode val="edge"/>
          <c:x val="0.2733490498540439"/>
          <c:y val="1.469045363426785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5.2962766870814491E-2"/>
          <c:y val="0.16225606039048845"/>
          <c:w val="0.84722611756625266"/>
          <c:h val="0.70407353555263286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63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21222812088603973"/>
                  <c:y val="3.9020505328470449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1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zh-CN"/>
                </a:p>
              </c:txPr>
            </c:trendlineLbl>
          </c:trendline>
          <c:xVal>
            <c:numRef>
              <c:f>Sheet1!$O$15:$T$15</c:f>
              <c:numCache>
                <c:formatCode>General</c:formatCode>
                <c:ptCount val="6"/>
                <c:pt idx="0">
                  <c:v>-1</c:v>
                </c:pt>
                <c:pt idx="1">
                  <c:v>-2</c:v>
                </c:pt>
                <c:pt idx="2">
                  <c:v>-3</c:v>
                </c:pt>
                <c:pt idx="3">
                  <c:v>-4</c:v>
                </c:pt>
                <c:pt idx="4">
                  <c:v>-5</c:v>
                </c:pt>
                <c:pt idx="5">
                  <c:v>-6</c:v>
                </c:pt>
              </c:numCache>
            </c:numRef>
          </c:xVal>
          <c:yVal>
            <c:numRef>
              <c:f>Sheet1!$O$16:$T$16</c:f>
              <c:numCache>
                <c:formatCode>General</c:formatCode>
                <c:ptCount val="6"/>
                <c:pt idx="0">
                  <c:v>13.526666666666666</c:v>
                </c:pt>
                <c:pt idx="1">
                  <c:v>16.106666666666666</c:v>
                </c:pt>
                <c:pt idx="2">
                  <c:v>20.376666666666665</c:v>
                </c:pt>
                <c:pt idx="3">
                  <c:v>23.416666666666668</c:v>
                </c:pt>
                <c:pt idx="4">
                  <c:v>26.466666666666665</c:v>
                </c:pt>
                <c:pt idx="5">
                  <c:v>30.9133333333333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9404-41B4-9891-25D5DB322B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32434992"/>
        <c:axId val="232435552"/>
      </c:scatterChart>
      <c:valAx>
        <c:axId val="2324349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32435552"/>
        <c:crosses val="autoZero"/>
        <c:crossBetween val="midCat"/>
      </c:valAx>
      <c:valAx>
        <c:axId val="232435552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324349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05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N2292_c0_g2</a:t>
            </a:r>
          </a:p>
          <a:p>
            <a:pPr>
              <a:defRPr sz="105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SERBP1)</a:t>
            </a:r>
          </a:p>
        </c:rich>
      </c:tx>
      <c:layout>
        <c:manualLayout>
          <c:xMode val="edge"/>
          <c:yMode val="edge"/>
          <c:x val="0.2733490498540439"/>
          <c:y val="1.469045363426785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5.2962766870814491E-2"/>
          <c:y val="0.16225606039048845"/>
          <c:w val="0.84722611756625266"/>
          <c:h val="0.70407353555263286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63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21222812088603973"/>
                  <c:y val="3.9020505328470449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1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zh-CN"/>
                </a:p>
              </c:txPr>
            </c:trendlineLbl>
          </c:trendline>
          <c:xVal>
            <c:numRef>
              <c:f>Sheet1!$O$23:$T$23</c:f>
              <c:numCache>
                <c:formatCode>General</c:formatCode>
                <c:ptCount val="6"/>
                <c:pt idx="0">
                  <c:v>-1</c:v>
                </c:pt>
                <c:pt idx="1">
                  <c:v>-2</c:v>
                </c:pt>
                <c:pt idx="2">
                  <c:v>-3</c:v>
                </c:pt>
                <c:pt idx="3">
                  <c:v>-4</c:v>
                </c:pt>
                <c:pt idx="4">
                  <c:v>-5</c:v>
                </c:pt>
                <c:pt idx="5">
                  <c:v>-6</c:v>
                </c:pt>
              </c:numCache>
            </c:numRef>
          </c:xVal>
          <c:yVal>
            <c:numRef>
              <c:f>Sheet1!$O$24:$T$24</c:f>
              <c:numCache>
                <c:formatCode>General</c:formatCode>
                <c:ptCount val="6"/>
                <c:pt idx="1">
                  <c:v>16.790000000000003</c:v>
                </c:pt>
                <c:pt idx="2">
                  <c:v>19.91</c:v>
                </c:pt>
                <c:pt idx="3">
                  <c:v>23.763333333333332</c:v>
                </c:pt>
                <c:pt idx="4">
                  <c:v>27.63</c:v>
                </c:pt>
                <c:pt idx="5">
                  <c:v>30.80666666666666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8937-450E-AD46-E391AFB985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30163008"/>
        <c:axId val="230163568"/>
      </c:scatterChart>
      <c:valAx>
        <c:axId val="2301630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30163568"/>
        <c:crosses val="autoZero"/>
        <c:crossBetween val="midCat"/>
      </c:valAx>
      <c:valAx>
        <c:axId val="230163568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3016300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4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05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N900_c0_g1</a:t>
            </a:r>
          </a:p>
          <a:p>
            <a:pPr>
              <a:defRPr sz="105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Cyclase)</a:t>
            </a:r>
          </a:p>
        </c:rich>
      </c:tx>
      <c:layout>
        <c:manualLayout>
          <c:xMode val="edge"/>
          <c:yMode val="edge"/>
          <c:x val="0.2733490498540439"/>
          <c:y val="1.469045363426785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5.2962766870814491E-2"/>
          <c:y val="0.16225606039048845"/>
          <c:w val="0.84722611756625266"/>
          <c:h val="0.70407353555263286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63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21938548484358747"/>
                  <c:y val="9.3056188628508146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1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zh-CN"/>
                </a:p>
              </c:txPr>
            </c:trendlineLbl>
          </c:trendline>
          <c:xVal>
            <c:numRef>
              <c:f>Sheet1!$O$27:$T$27</c:f>
              <c:numCache>
                <c:formatCode>General</c:formatCode>
                <c:ptCount val="6"/>
                <c:pt idx="0">
                  <c:v>-1</c:v>
                </c:pt>
                <c:pt idx="1">
                  <c:v>-2</c:v>
                </c:pt>
                <c:pt idx="2">
                  <c:v>-3</c:v>
                </c:pt>
                <c:pt idx="3">
                  <c:v>-4</c:v>
                </c:pt>
                <c:pt idx="4">
                  <c:v>-5</c:v>
                </c:pt>
                <c:pt idx="5">
                  <c:v>-6</c:v>
                </c:pt>
              </c:numCache>
            </c:numRef>
          </c:xVal>
          <c:yVal>
            <c:numRef>
              <c:f>Sheet1!$O$28:$T$28</c:f>
              <c:numCache>
                <c:formatCode>General</c:formatCode>
                <c:ptCount val="6"/>
                <c:pt idx="0">
                  <c:v>12.216666666666669</c:v>
                </c:pt>
                <c:pt idx="1">
                  <c:v>15.32</c:v>
                </c:pt>
                <c:pt idx="2">
                  <c:v>18.116666666666671</c:v>
                </c:pt>
                <c:pt idx="3">
                  <c:v>21.216666666666669</c:v>
                </c:pt>
                <c:pt idx="4">
                  <c:v>24.536666666666665</c:v>
                </c:pt>
                <c:pt idx="5">
                  <c:v>27.92333333333333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6372-423D-970E-91D13A5D8D3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30306272"/>
        <c:axId val="230306832"/>
      </c:scatterChart>
      <c:valAx>
        <c:axId val="2303062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30306832"/>
        <c:crosses val="autoZero"/>
        <c:crossBetween val="midCat"/>
      </c:valAx>
      <c:valAx>
        <c:axId val="230306832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3030627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4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05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N8079_c1_g3</a:t>
            </a:r>
          </a:p>
          <a:p>
            <a:pPr>
              <a:defRPr sz="105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HMG_B1)</a:t>
            </a:r>
          </a:p>
        </c:rich>
      </c:tx>
      <c:layout>
        <c:manualLayout>
          <c:xMode val="edge"/>
          <c:yMode val="edge"/>
          <c:x val="0.2733490498540439"/>
          <c:y val="1.469045363426785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5.2962766870814491E-2"/>
          <c:y val="0.16225606039048845"/>
          <c:w val="0.84722611756625266"/>
          <c:h val="0.70407353555263286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63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23813484103581878"/>
                  <c:y val="1.5610424815885629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1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zh-CN"/>
                </a:p>
              </c:txPr>
            </c:trendlineLbl>
          </c:trendline>
          <c:xVal>
            <c:numRef>
              <c:f>Sheet1!$O$31:$T$31</c:f>
              <c:numCache>
                <c:formatCode>General</c:formatCode>
                <c:ptCount val="6"/>
                <c:pt idx="0">
                  <c:v>-1</c:v>
                </c:pt>
                <c:pt idx="1">
                  <c:v>-2</c:v>
                </c:pt>
                <c:pt idx="2">
                  <c:v>-3</c:v>
                </c:pt>
                <c:pt idx="3">
                  <c:v>-4</c:v>
                </c:pt>
                <c:pt idx="4">
                  <c:v>-5</c:v>
                </c:pt>
                <c:pt idx="5">
                  <c:v>-6</c:v>
                </c:pt>
              </c:numCache>
            </c:numRef>
          </c:xVal>
          <c:yVal>
            <c:numRef>
              <c:f>Sheet1!$O$32:$T$32</c:f>
              <c:numCache>
                <c:formatCode>General</c:formatCode>
                <c:ptCount val="6"/>
                <c:pt idx="0">
                  <c:v>13.256666666666666</c:v>
                </c:pt>
                <c:pt idx="1">
                  <c:v>14.01</c:v>
                </c:pt>
                <c:pt idx="2">
                  <c:v>18.773333333333333</c:v>
                </c:pt>
                <c:pt idx="3">
                  <c:v>22.253333333333334</c:v>
                </c:pt>
                <c:pt idx="4">
                  <c:v>25.556666666666661</c:v>
                </c:pt>
                <c:pt idx="5">
                  <c:v>29.03333333333333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AD9F-4C17-9A31-28936CA06D5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1593200"/>
        <c:axId val="251593760"/>
      </c:scatterChart>
      <c:valAx>
        <c:axId val="2515932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51593760"/>
        <c:crosses val="autoZero"/>
        <c:crossBetween val="midCat"/>
      </c:valAx>
      <c:valAx>
        <c:axId val="251593760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5159320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4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05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N25286_c0_g3</a:t>
            </a:r>
          </a:p>
          <a:p>
            <a:pPr>
              <a:defRPr sz="105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SEM1)</a:t>
            </a:r>
          </a:p>
        </c:rich>
      </c:tx>
      <c:layout>
        <c:manualLayout>
          <c:xMode val="edge"/>
          <c:yMode val="edge"/>
          <c:x val="0.2733490498540439"/>
          <c:y val="1.469045363426785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5.2962766870814491E-2"/>
          <c:y val="0.16225606039048845"/>
          <c:w val="0.84722611756625266"/>
          <c:h val="0.70407353555263286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63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21222812088603973"/>
                  <c:y val="3.9020505328470449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1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zh-CN"/>
                </a:p>
              </c:txPr>
            </c:trendlineLbl>
          </c:trendline>
          <c:xVal>
            <c:numRef>
              <c:f>Sheet1!$O$35:$T$35</c:f>
              <c:numCache>
                <c:formatCode>General</c:formatCode>
                <c:ptCount val="6"/>
                <c:pt idx="0">
                  <c:v>-1</c:v>
                </c:pt>
                <c:pt idx="1">
                  <c:v>-2</c:v>
                </c:pt>
                <c:pt idx="2">
                  <c:v>-3</c:v>
                </c:pt>
                <c:pt idx="3">
                  <c:v>-4</c:v>
                </c:pt>
                <c:pt idx="4">
                  <c:v>-5</c:v>
                </c:pt>
                <c:pt idx="5">
                  <c:v>-6</c:v>
                </c:pt>
              </c:numCache>
            </c:numRef>
          </c:xVal>
          <c:yVal>
            <c:numRef>
              <c:f>Sheet1!$O$36:$T$36</c:f>
              <c:numCache>
                <c:formatCode>General</c:formatCode>
                <c:ptCount val="6"/>
                <c:pt idx="0">
                  <c:v>12.58</c:v>
                </c:pt>
                <c:pt idx="1">
                  <c:v>15.086666666666666</c:v>
                </c:pt>
                <c:pt idx="2">
                  <c:v>19.743333333333336</c:v>
                </c:pt>
                <c:pt idx="3">
                  <c:v>23.439999999999998</c:v>
                </c:pt>
                <c:pt idx="4">
                  <c:v>26.706666666666667</c:v>
                </c:pt>
                <c:pt idx="5">
                  <c:v>29.66333333333333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7F8E-4FC9-9424-45E715E0889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4985952"/>
        <c:axId val="254986512"/>
      </c:scatterChart>
      <c:valAx>
        <c:axId val="2549859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54986512"/>
        <c:crosses val="autoZero"/>
        <c:crossBetween val="midCat"/>
      </c:valAx>
      <c:valAx>
        <c:axId val="254986512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5498595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4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050" b="1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N374_c0_g1</a:t>
            </a:r>
          </a:p>
          <a:p>
            <a:pPr>
              <a:defRPr sz="1050" b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GLO1)</a:t>
            </a:r>
          </a:p>
        </c:rich>
      </c:tx>
      <c:layout>
        <c:manualLayout>
          <c:xMode val="edge"/>
          <c:yMode val="edge"/>
          <c:x val="0.2733490498540439"/>
          <c:y val="1.469045363426785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1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title>
    <c:autoTitleDeleted val="0"/>
    <c:plotArea>
      <c:layout>
        <c:manualLayout>
          <c:layoutTarget val="inner"/>
          <c:xMode val="edge"/>
          <c:yMode val="edge"/>
          <c:x val="5.2962766870814491E-2"/>
          <c:y val="0.16225606039048845"/>
          <c:w val="0.84722611756625266"/>
          <c:h val="0.70407353555263286"/>
        </c:manualLayout>
      </c:layout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6350" cap="rnd">
                <a:solidFill>
                  <a:schemeClr val="tx1"/>
                </a:solidFill>
                <a:prstDash val="solid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21222812088603973"/>
                  <c:y val="3.9020505328470449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1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zh-CN"/>
                </a:p>
              </c:txPr>
            </c:trendlineLbl>
          </c:trendline>
          <c:xVal>
            <c:numRef>
              <c:f>Sheet1!$O$39:$T$39</c:f>
              <c:numCache>
                <c:formatCode>General</c:formatCode>
                <c:ptCount val="6"/>
                <c:pt idx="0">
                  <c:v>-1</c:v>
                </c:pt>
                <c:pt idx="1">
                  <c:v>-2</c:v>
                </c:pt>
                <c:pt idx="2">
                  <c:v>-3</c:v>
                </c:pt>
                <c:pt idx="3">
                  <c:v>-4</c:v>
                </c:pt>
                <c:pt idx="4">
                  <c:v>-5</c:v>
                </c:pt>
                <c:pt idx="5">
                  <c:v>-6</c:v>
                </c:pt>
              </c:numCache>
            </c:numRef>
          </c:xVal>
          <c:yVal>
            <c:numRef>
              <c:f>Sheet1!$O$40:$T$40</c:f>
              <c:numCache>
                <c:formatCode>General</c:formatCode>
                <c:ptCount val="6"/>
                <c:pt idx="0">
                  <c:v>13.196666666666667</c:v>
                </c:pt>
                <c:pt idx="1">
                  <c:v>15.346666666666666</c:v>
                </c:pt>
                <c:pt idx="2">
                  <c:v>18.689999999999998</c:v>
                </c:pt>
                <c:pt idx="3">
                  <c:v>21.89</c:v>
                </c:pt>
                <c:pt idx="4">
                  <c:v>25.866666666666664</c:v>
                </c:pt>
                <c:pt idx="5">
                  <c:v>29.17666666666666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348C-4B4C-814E-1504604D22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46606272"/>
        <c:axId val="246606832"/>
      </c:scatterChart>
      <c:valAx>
        <c:axId val="2466062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46606832"/>
        <c:crosses val="autoZero"/>
        <c:crossBetween val="midCat"/>
      </c:valAx>
      <c:valAx>
        <c:axId val="246606832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high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4660627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CN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589DD-6853-4BC9-9852-38A4F06F2C7D}" type="datetimeFigureOut">
              <a:rPr lang="en-US" smtClean="0"/>
              <a:t>6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DCFBA-6749-499E-BE62-61A1E1B47B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75259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589DD-6853-4BC9-9852-38A4F06F2C7D}" type="datetimeFigureOut">
              <a:rPr lang="en-US" smtClean="0"/>
              <a:t>6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DCFBA-6749-499E-BE62-61A1E1B47B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32041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589DD-6853-4BC9-9852-38A4F06F2C7D}" type="datetimeFigureOut">
              <a:rPr lang="en-US" smtClean="0"/>
              <a:t>6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DCFBA-6749-499E-BE62-61A1E1B47B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69639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589DD-6853-4BC9-9852-38A4F06F2C7D}" type="datetimeFigureOut">
              <a:rPr lang="en-US" smtClean="0"/>
              <a:t>6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DCFBA-6749-499E-BE62-61A1E1B47B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41068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589DD-6853-4BC9-9852-38A4F06F2C7D}" type="datetimeFigureOut">
              <a:rPr lang="en-US" smtClean="0"/>
              <a:t>6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DCFBA-6749-499E-BE62-61A1E1B47B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7488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589DD-6853-4BC9-9852-38A4F06F2C7D}" type="datetimeFigureOut">
              <a:rPr lang="en-US" smtClean="0"/>
              <a:t>6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DCFBA-6749-499E-BE62-61A1E1B47B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78566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589DD-6853-4BC9-9852-38A4F06F2C7D}" type="datetimeFigureOut">
              <a:rPr lang="en-US" smtClean="0"/>
              <a:t>6/2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DCFBA-6749-499E-BE62-61A1E1B47B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17116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589DD-6853-4BC9-9852-38A4F06F2C7D}" type="datetimeFigureOut">
              <a:rPr lang="en-US" smtClean="0"/>
              <a:t>6/2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DCFBA-6749-499E-BE62-61A1E1B47B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58070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589DD-6853-4BC9-9852-38A4F06F2C7D}" type="datetimeFigureOut">
              <a:rPr lang="en-US" smtClean="0"/>
              <a:t>6/2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DCFBA-6749-499E-BE62-61A1E1B47B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86532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589DD-6853-4BC9-9852-38A4F06F2C7D}" type="datetimeFigureOut">
              <a:rPr lang="en-US" smtClean="0"/>
              <a:t>6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DCFBA-6749-499E-BE62-61A1E1B47B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41652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589DD-6853-4BC9-9852-38A4F06F2C7D}" type="datetimeFigureOut">
              <a:rPr lang="en-US" smtClean="0"/>
              <a:t>6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DCFBA-6749-499E-BE62-61A1E1B47B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03233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F589DD-6853-4BC9-9852-38A4F06F2C7D}" type="datetimeFigureOut">
              <a:rPr lang="en-US" smtClean="0"/>
              <a:t>6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5DCFBA-6749-499E-BE62-61A1E1B47B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87204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>
            <a:extLst>
              <a:ext uri="{FF2B5EF4-FFF2-40B4-BE49-F238E27FC236}">
                <a16:creationId xmlns:a16="http://schemas.microsoft.com/office/drawing/2014/main" xmlns="" id="{A89A0867-AB84-419E-BB19-CFDC4765ADB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5373" y="2870460"/>
            <a:ext cx="3733579" cy="2453197"/>
          </a:xfrm>
          <a:prstGeom prst="rect">
            <a:avLst/>
          </a:prstGeom>
        </p:spPr>
      </p:pic>
      <p:sp>
        <p:nvSpPr>
          <p:cNvPr id="18" name="TextBox 5">
            <a:extLst>
              <a:ext uri="{FF2B5EF4-FFF2-40B4-BE49-F238E27FC236}">
                <a16:creationId xmlns:a16="http://schemas.microsoft.com/office/drawing/2014/main" xmlns="" id="{33FBBE5A-DCE5-4AD8-899D-D0AF57B5F6CF}"/>
              </a:ext>
            </a:extLst>
          </p:cNvPr>
          <p:cNvSpPr txBox="1"/>
          <p:nvPr/>
        </p:nvSpPr>
        <p:spPr>
          <a:xfrm>
            <a:off x="472896" y="5494710"/>
            <a:ext cx="597369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1. Confirmation of primer specificity and amplicon size. </a:t>
            </a:r>
            <a:r>
              <a:rPr lang="en-US" sz="12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mplification results from the 10 candidate reference genes an 2 controls using </a:t>
            </a:r>
            <a:r>
              <a:rPr lang="en-US" sz="12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DNA template from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A. </a:t>
            </a:r>
            <a:r>
              <a:rPr lang="en-US" sz="1200" i="1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uberosum</a:t>
            </a:r>
            <a:r>
              <a:rPr lang="en-US" sz="12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leaves</a:t>
            </a:r>
            <a:r>
              <a:rPr lang="en-US" sz="1200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0.8% agarose gel was used for electrophoresis, and Trans5K DNA Marker (rightmost lane) was used to estimate amplicon size.</a:t>
            </a:r>
            <a:endParaRPr lang="en-US" sz="12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4609190" y="3408572"/>
            <a:ext cx="47976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solidFill>
                  <a:schemeClr val="bg1"/>
                </a:solidFill>
              </a:rPr>
              <a:t>5000 </a:t>
            </a:r>
            <a:r>
              <a:rPr lang="en-US" altLang="zh-CN" sz="700" dirty="0" err="1">
                <a:solidFill>
                  <a:schemeClr val="bg1"/>
                </a:solidFill>
              </a:rPr>
              <a:t>bp</a:t>
            </a:r>
            <a:endParaRPr lang="zh-CN" altLang="en-US" sz="700" dirty="0">
              <a:solidFill>
                <a:schemeClr val="bg1"/>
              </a:solidFill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4609190" y="3519543"/>
            <a:ext cx="47976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solidFill>
                  <a:schemeClr val="bg1"/>
                </a:solidFill>
              </a:rPr>
              <a:t>3000 </a:t>
            </a:r>
            <a:r>
              <a:rPr lang="en-US" altLang="zh-CN" sz="700" dirty="0" err="1">
                <a:solidFill>
                  <a:schemeClr val="bg1"/>
                </a:solidFill>
              </a:rPr>
              <a:t>bp</a:t>
            </a:r>
            <a:endParaRPr lang="zh-CN" altLang="en-US" sz="700" dirty="0">
              <a:solidFill>
                <a:schemeClr val="bg1"/>
              </a:solidFill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4609190" y="3619311"/>
            <a:ext cx="47976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solidFill>
                  <a:schemeClr val="bg1"/>
                </a:solidFill>
              </a:rPr>
              <a:t>2000 </a:t>
            </a:r>
            <a:r>
              <a:rPr lang="en-US" altLang="zh-CN" sz="700" dirty="0" err="1">
                <a:solidFill>
                  <a:schemeClr val="bg1"/>
                </a:solidFill>
              </a:rPr>
              <a:t>bp</a:t>
            </a:r>
            <a:endParaRPr lang="zh-CN" altLang="en-US" sz="700" dirty="0">
              <a:solidFill>
                <a:schemeClr val="bg1"/>
              </a:solidFill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4609190" y="3714474"/>
            <a:ext cx="47976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solidFill>
                  <a:schemeClr val="bg1"/>
                </a:solidFill>
              </a:rPr>
              <a:t>1500 </a:t>
            </a:r>
            <a:r>
              <a:rPr lang="en-US" altLang="zh-CN" sz="700" dirty="0" err="1">
                <a:solidFill>
                  <a:schemeClr val="bg1"/>
                </a:solidFill>
              </a:rPr>
              <a:t>bp</a:t>
            </a:r>
            <a:endParaRPr lang="zh-CN" altLang="en-US" sz="700" dirty="0">
              <a:solidFill>
                <a:schemeClr val="bg1"/>
              </a:solidFill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4609190" y="3809637"/>
            <a:ext cx="47976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solidFill>
                  <a:schemeClr val="bg1"/>
                </a:solidFill>
              </a:rPr>
              <a:t>1000 </a:t>
            </a:r>
            <a:r>
              <a:rPr lang="en-US" altLang="zh-CN" sz="700" dirty="0" err="1">
                <a:solidFill>
                  <a:schemeClr val="bg1"/>
                </a:solidFill>
              </a:rPr>
              <a:t>bp</a:t>
            </a:r>
            <a:endParaRPr lang="zh-CN" altLang="en-US" sz="700" dirty="0">
              <a:solidFill>
                <a:schemeClr val="bg1"/>
              </a:solidFill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4609190" y="3897003"/>
            <a:ext cx="47976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solidFill>
                  <a:schemeClr val="bg1"/>
                </a:solidFill>
              </a:rPr>
              <a:t>800 </a:t>
            </a:r>
            <a:r>
              <a:rPr lang="en-US" altLang="zh-CN" sz="700" dirty="0" err="1">
                <a:solidFill>
                  <a:schemeClr val="bg1"/>
                </a:solidFill>
              </a:rPr>
              <a:t>bp</a:t>
            </a:r>
            <a:endParaRPr lang="zh-CN" altLang="en-US" sz="700" dirty="0">
              <a:solidFill>
                <a:schemeClr val="bg1"/>
              </a:solidFill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4609190" y="4004568"/>
            <a:ext cx="47976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solidFill>
                  <a:schemeClr val="bg1"/>
                </a:solidFill>
              </a:rPr>
              <a:t>500 </a:t>
            </a:r>
            <a:r>
              <a:rPr lang="en-US" altLang="zh-CN" sz="700" dirty="0" err="1">
                <a:solidFill>
                  <a:schemeClr val="bg1"/>
                </a:solidFill>
              </a:rPr>
              <a:t>bp</a:t>
            </a:r>
            <a:endParaRPr lang="zh-CN" altLang="en-US" sz="700" dirty="0">
              <a:solidFill>
                <a:schemeClr val="bg1"/>
              </a:solidFill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4609190" y="4087329"/>
            <a:ext cx="47976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>
                <a:solidFill>
                  <a:schemeClr val="bg1"/>
                </a:solidFill>
              </a:rPr>
              <a:t>300 </a:t>
            </a:r>
            <a:r>
              <a:rPr lang="en-US" altLang="zh-CN" sz="700" dirty="0" err="1">
                <a:solidFill>
                  <a:schemeClr val="bg1"/>
                </a:solidFill>
              </a:rPr>
              <a:t>bp</a:t>
            </a:r>
            <a:endParaRPr lang="zh-CN" altLang="en-US" sz="700" dirty="0">
              <a:solidFill>
                <a:schemeClr val="bg1"/>
              </a:solidFill>
            </a:endParaRPr>
          </a:p>
        </p:txBody>
      </p:sp>
      <p:sp>
        <p:nvSpPr>
          <p:cNvPr id="33" name="文本框 32"/>
          <p:cNvSpPr txBox="1"/>
          <p:nvPr/>
        </p:nvSpPr>
        <p:spPr>
          <a:xfrm rot="5400000">
            <a:off x="3676060" y="2115111"/>
            <a:ext cx="14676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2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DN2684_c0_g1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 rot="5400000">
            <a:off x="3429693" y="2115111"/>
            <a:ext cx="14676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IF1</a:t>
            </a:r>
            <a:r>
              <a:rPr lang="el-GR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l-GR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17056_c0_g1</a:t>
            </a:r>
          </a:p>
        </p:txBody>
      </p:sp>
      <p:sp>
        <p:nvSpPr>
          <p:cNvPr id="35" name="文本框 34"/>
          <p:cNvSpPr txBox="1"/>
          <p:nvPr/>
        </p:nvSpPr>
        <p:spPr>
          <a:xfrm rot="5400000">
            <a:off x="3154197" y="2115111"/>
            <a:ext cx="14676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O1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DN374_c0_g1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 rot="5400000">
            <a:off x="2904636" y="2115111"/>
            <a:ext cx="14676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M1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DN25286_c0_g3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 rot="5400000">
            <a:off x="2638437" y="2115111"/>
            <a:ext cx="14676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MG_B1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DN8079_c1_g3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 rot="5400000">
            <a:off x="2383881" y="2115111"/>
            <a:ext cx="14676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clase_X1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DN900_c0_g1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 rot="5400000">
            <a:off x="2133925" y="2115111"/>
            <a:ext cx="14676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RBP1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DN2922_c0_g2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 rot="5400000">
            <a:off x="1879711" y="2115111"/>
            <a:ext cx="14676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2022_c2_g1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 rot="5400000">
            <a:off x="1636734" y="2115111"/>
            <a:ext cx="14676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RMC1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DN18197_c0_g1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 rot="5400000">
            <a:off x="1381620" y="2115111"/>
            <a:ext cx="14676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S_X31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DN6928_c0_g1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 rot="5400000">
            <a:off x="1114670" y="2115111"/>
            <a:ext cx="14676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KP1</a:t>
            </a:r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DN253_c0_g1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 rot="5400000">
            <a:off x="847720" y="2115111"/>
            <a:ext cx="14676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N12657_c0_g1</a:t>
            </a:r>
            <a:endParaRPr lang="zh-CN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1355372" y="1502069"/>
            <a:ext cx="25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连接符 25"/>
          <p:cNvCxnSpPr/>
          <p:nvPr/>
        </p:nvCxnSpPr>
        <p:spPr>
          <a:xfrm>
            <a:off x="4067688" y="1502069"/>
            <a:ext cx="4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矩形 4"/>
          <p:cNvSpPr/>
          <p:nvPr/>
        </p:nvSpPr>
        <p:spPr>
          <a:xfrm>
            <a:off x="1355372" y="1255473"/>
            <a:ext cx="25920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ndidate reference genes 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矩形 27"/>
          <p:cNvSpPr/>
          <p:nvPr/>
        </p:nvSpPr>
        <p:spPr>
          <a:xfrm>
            <a:off x="3834975" y="1255473"/>
            <a:ext cx="8867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s</a:t>
            </a:r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96316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xmlns="" id="{792A52D4-9869-48BF-8F60-8F958BABDC4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80105962"/>
              </p:ext>
            </p:extLst>
          </p:nvPr>
        </p:nvGraphicFramePr>
        <p:xfrm>
          <a:off x="130391" y="1362410"/>
          <a:ext cx="2103120" cy="1280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xmlns="" id="{2CA32EC4-2D4C-4074-B1D7-75EA82BC7B6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74019857"/>
              </p:ext>
            </p:extLst>
          </p:nvPr>
        </p:nvGraphicFramePr>
        <p:xfrm>
          <a:off x="2377440" y="1362410"/>
          <a:ext cx="2103120" cy="1280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xmlns="" id="{80893CC7-D7E2-4116-8104-A7BDA5BD9F0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33495105"/>
              </p:ext>
            </p:extLst>
          </p:nvPr>
        </p:nvGraphicFramePr>
        <p:xfrm>
          <a:off x="4573889" y="1362410"/>
          <a:ext cx="2103120" cy="1280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xmlns="" id="{D8D50DF5-862E-4CE4-9482-7008B2DC70E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4422316"/>
              </p:ext>
            </p:extLst>
          </p:nvPr>
        </p:nvGraphicFramePr>
        <p:xfrm>
          <a:off x="130391" y="2744284"/>
          <a:ext cx="2103120" cy="1280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xmlns="" id="{3116D9F1-63FB-4313-8E7B-E24C1B91C3B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35869977"/>
              </p:ext>
            </p:extLst>
          </p:nvPr>
        </p:nvGraphicFramePr>
        <p:xfrm>
          <a:off x="4573889" y="2744284"/>
          <a:ext cx="2103120" cy="1280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xmlns="" id="{5E5F506E-1CC3-4697-B851-BA52EBC5231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94417595"/>
              </p:ext>
            </p:extLst>
          </p:nvPr>
        </p:nvGraphicFramePr>
        <p:xfrm>
          <a:off x="130391" y="4114903"/>
          <a:ext cx="2103120" cy="1280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xmlns="" id="{BFCC9FF3-2E7D-4CC0-A6DA-0FB11337035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62727974"/>
              </p:ext>
            </p:extLst>
          </p:nvPr>
        </p:nvGraphicFramePr>
        <p:xfrm>
          <a:off x="2377440" y="4114903"/>
          <a:ext cx="2103120" cy="1280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xmlns="" id="{DCE8AB15-5E00-4B71-9C31-105850B7CBF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95729112"/>
              </p:ext>
            </p:extLst>
          </p:nvPr>
        </p:nvGraphicFramePr>
        <p:xfrm>
          <a:off x="4573889" y="4114903"/>
          <a:ext cx="2103120" cy="1280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xmlns="" id="{FC5D84D1-DAD6-436A-8F8B-9B672B909D2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79531864"/>
              </p:ext>
            </p:extLst>
          </p:nvPr>
        </p:nvGraphicFramePr>
        <p:xfrm>
          <a:off x="130391" y="5564631"/>
          <a:ext cx="2103120" cy="1280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xmlns="" id="{5C177FFA-BC78-4852-84C6-7616FC7C042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8950025"/>
              </p:ext>
            </p:extLst>
          </p:nvPr>
        </p:nvGraphicFramePr>
        <p:xfrm>
          <a:off x="2377440" y="5564631"/>
          <a:ext cx="2103120" cy="1280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xmlns="" id="{6B38FEA7-6DE7-4878-BA31-F796A3366D6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09656732"/>
              </p:ext>
            </p:extLst>
          </p:nvPr>
        </p:nvGraphicFramePr>
        <p:xfrm>
          <a:off x="4573889" y="5564631"/>
          <a:ext cx="2103120" cy="1280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14" name="TextBox 5">
            <a:extLst>
              <a:ext uri="{FF2B5EF4-FFF2-40B4-BE49-F238E27FC236}">
                <a16:creationId xmlns:a16="http://schemas.microsoft.com/office/drawing/2014/main" xmlns="" id="{22509560-6BFE-4BEF-948B-DD93C4F46769}"/>
              </a:ext>
            </a:extLst>
          </p:cNvPr>
          <p:cNvSpPr txBox="1"/>
          <p:nvPr/>
        </p:nvSpPr>
        <p:spPr>
          <a:xfrm>
            <a:off x="164496" y="7114482"/>
            <a:ext cx="66105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2.  Standard curves for primer pairs </a:t>
            </a:r>
            <a:r>
              <a:rPr lang="en-US" sz="1200" b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of 10 reference candidate genes and 2 controls in</a:t>
            </a:r>
            <a:r>
              <a:rPr lang="en-US" sz="1200" b="1" i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A. </a:t>
            </a:r>
            <a:r>
              <a:rPr lang="en-US" sz="1200" b="1" i="1" dirty="0" err="1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uberosum</a:t>
            </a:r>
            <a:r>
              <a:rPr lang="en-US" sz="1200" b="1" dirty="0"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endParaRPr lang="en-US" sz="1200" b="1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graphicFrame>
        <p:nvGraphicFramePr>
          <p:cNvPr id="15" name="Chart 5">
            <a:extLst>
              <a:ext uri="{FF2B5EF4-FFF2-40B4-BE49-F238E27FC236}">
                <a16:creationId xmlns:a16="http://schemas.microsoft.com/office/drawing/2014/main" xmlns="" id="{08ED8A81-C473-4215-97EA-AE10F7EBCEE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39260691"/>
              </p:ext>
            </p:extLst>
          </p:nvPr>
        </p:nvGraphicFramePr>
        <p:xfrm>
          <a:off x="2373520" y="2737936"/>
          <a:ext cx="2102400" cy="1281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</p:spTree>
    <p:extLst>
      <p:ext uri="{BB962C8B-B14F-4D97-AF65-F5344CB8AC3E}">
        <p14:creationId xmlns:p14="http://schemas.microsoft.com/office/powerpoint/2010/main" val="13014662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7F47A90D-9609-4352-B7C5-BF0738F2927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444" t="12445" r="10444" b="12222"/>
          <a:stretch/>
        </p:blipFill>
        <p:spPr>
          <a:xfrm>
            <a:off x="1859280" y="1062262"/>
            <a:ext cx="3535680" cy="3366842"/>
          </a:xfrm>
          <a:prstGeom prst="rect">
            <a:avLst/>
          </a:prstGeom>
        </p:spPr>
      </p:pic>
      <p:sp>
        <p:nvSpPr>
          <p:cNvPr id="5" name="TextBox 5">
            <a:extLst>
              <a:ext uri="{FF2B5EF4-FFF2-40B4-BE49-F238E27FC236}">
                <a16:creationId xmlns:a16="http://schemas.microsoft.com/office/drawing/2014/main" xmlns="" id="{7964D2C9-BFFA-4C70-9A2F-6704C225F2E8}"/>
              </a:ext>
            </a:extLst>
          </p:cNvPr>
          <p:cNvSpPr txBox="1"/>
          <p:nvPr/>
        </p:nvSpPr>
        <p:spPr>
          <a:xfrm>
            <a:off x="450805" y="4839664"/>
            <a:ext cx="61023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3.  Venn diagrams of top 20 stable genes identified according to the Euclidean distance (d) , CV, or NMAD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B13C41C8-C783-456B-8A48-0A3E9F4BB8ED}"/>
              </a:ext>
            </a:extLst>
          </p:cNvPr>
          <p:cNvSpPr txBox="1"/>
          <p:nvPr/>
        </p:nvSpPr>
        <p:spPr>
          <a:xfrm>
            <a:off x="2180491" y="830145"/>
            <a:ext cx="11676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d</a:t>
            </a:r>
            <a:r>
              <a:rPr lang="en-US" sz="1400" dirty="0"/>
              <a:t> ranking lis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5298B6FB-7BCF-462F-ADB8-2CFBC99C9329}"/>
              </a:ext>
            </a:extLst>
          </p:cNvPr>
          <p:cNvSpPr txBox="1"/>
          <p:nvPr/>
        </p:nvSpPr>
        <p:spPr>
          <a:xfrm>
            <a:off x="3812344" y="830145"/>
            <a:ext cx="13856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CV</a:t>
            </a:r>
            <a:r>
              <a:rPr lang="en-US" sz="1400" dirty="0"/>
              <a:t> ranking list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B7D1147C-1845-429F-B7E1-73AAD4ADEE50}"/>
              </a:ext>
            </a:extLst>
          </p:cNvPr>
          <p:cNvSpPr txBox="1"/>
          <p:nvPr/>
        </p:nvSpPr>
        <p:spPr>
          <a:xfrm>
            <a:off x="3006967" y="4352159"/>
            <a:ext cx="14982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NMAD</a:t>
            </a:r>
            <a:r>
              <a:rPr lang="en-US" sz="1400" dirty="0"/>
              <a:t> ranking list</a:t>
            </a:r>
          </a:p>
        </p:txBody>
      </p:sp>
    </p:spTree>
    <p:extLst>
      <p:ext uri="{BB962C8B-B14F-4D97-AF65-F5344CB8AC3E}">
        <p14:creationId xmlns:p14="http://schemas.microsoft.com/office/powerpoint/2010/main" val="7680802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0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1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9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13</TotalTime>
  <Words>190</Words>
  <Application>Microsoft Office PowerPoint</Application>
  <PresentationFormat>A4 纸张(210x297 毫米)</PresentationFormat>
  <Paragraphs>50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9" baseType="lpstr">
      <vt:lpstr>等线</vt:lpstr>
      <vt:lpstr>Arial</vt:lpstr>
      <vt:lpstr>Calibri</vt:lpstr>
      <vt:lpstr>Calibri Light</vt:lpstr>
      <vt:lpstr>Times New Roman</vt:lpstr>
      <vt:lpstr>Office Theme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ng Liu</dc:creator>
  <cp:lastModifiedBy>Ning</cp:lastModifiedBy>
  <cp:revision>80</cp:revision>
  <cp:lastPrinted>2021-02-01T07:05:21Z</cp:lastPrinted>
  <dcterms:created xsi:type="dcterms:W3CDTF">2021-01-11T07:13:48Z</dcterms:created>
  <dcterms:modified xsi:type="dcterms:W3CDTF">2021-06-27T07:11:12Z</dcterms:modified>
</cp:coreProperties>
</file>